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8.bin" ContentType="application/vnd.openxmlformats-officedocument.oleObject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61123C-C4B4-4683-8399-4E0AC82E01B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108EA4-745A-4745-AE28-1854F87C8F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6C541A-2A3F-41C0-86BE-177D6FFD312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704EEB-EDB3-477C-BE91-A941F76D6D2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9A2F48-C50C-43C8-81D3-4F25E7E392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634CFF-EBA0-4581-81CE-7197D5FEDDA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21A9B5-058B-4100-87AD-A27E095EEA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57220C-C5C3-4A9A-A948-5B0B321DA6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25E0F7-2935-46E3-A204-2E51564FBE0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3AB7EA-5176-4C57-A857-907259E8D6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429D37-5CD1-4A46-870C-9DBB612E96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6CBD9A-11C2-4D9B-B7EB-FB7D30E585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D8929E9-9075-4340-B356-FBE77078CFF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png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png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7.png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8.png"/><Relationship Id="rId1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feld 4"/>
          <p:cNvSpPr/>
          <p:nvPr/>
        </p:nvSpPr>
        <p:spPr>
          <a:xfrm>
            <a:off x="47520" y="30240"/>
            <a:ext cx="2076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912960" y="1057320"/>
            <a:ext cx="145800" cy="71424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278000" y="1442880"/>
            <a:ext cx="144360" cy="33192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641600" y="1079640"/>
            <a:ext cx="145800" cy="69516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004840" y="1467000"/>
            <a:ext cx="146160" cy="30780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flipV="1">
            <a:off x="985680" y="976320"/>
            <a:ext cx="1800" cy="856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973080" y="971640"/>
            <a:ext cx="28800" cy="14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 flipV="1">
            <a:off x="1349280" y="1272960"/>
            <a:ext cx="1800" cy="1695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338120" y="1273320"/>
            <a:ext cx="28800" cy="14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 flipV="1">
            <a:off x="1714680" y="1017720"/>
            <a:ext cx="1440" cy="619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5120" bIns="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701720" y="1017720"/>
            <a:ext cx="28800" cy="14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flipV="1">
            <a:off x="2077920" y="1351080"/>
            <a:ext cx="1800" cy="1188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065320" y="1351080"/>
            <a:ext cx="28440" cy="14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803160" y="887400"/>
            <a:ext cx="1800" cy="8874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787320" y="1774800"/>
            <a:ext cx="158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787320" y="1628640"/>
            <a:ext cx="1584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787320" y="1481040"/>
            <a:ext cx="1584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787320" y="1335240"/>
            <a:ext cx="158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787320" y="1181160"/>
            <a:ext cx="158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787320" y="1033560"/>
            <a:ext cx="158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787320" y="887400"/>
            <a:ext cx="158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803160" y="1774800"/>
            <a:ext cx="14572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flipV="1">
            <a:off x="803160" y="1774800"/>
            <a:ext cx="180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 flipV="1">
            <a:off x="1168560" y="1774800"/>
            <a:ext cx="144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 flipV="1">
            <a:off x="1531800" y="1774800"/>
            <a:ext cx="180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flipV="1">
            <a:off x="1895400" y="1774800"/>
            <a:ext cx="180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 flipV="1">
            <a:off x="2260440" y="1774800"/>
            <a:ext cx="180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1302840" y="512640"/>
            <a:ext cx="339120" cy="182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5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618120" y="1700280"/>
            <a:ext cx="145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0.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618120" y="1549440"/>
            <a:ext cx="145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0.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618120" y="1400040"/>
            <a:ext cx="145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0.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616320" y="1262160"/>
            <a:ext cx="145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0.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613080" y="1104840"/>
            <a:ext cx="145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0.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618120" y="960480"/>
            <a:ext cx="145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1.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618120" y="811080"/>
            <a:ext cx="145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1.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 rot="16200000">
            <a:off x="-187560" y="1151280"/>
            <a:ext cx="986760" cy="2746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900" spc="-1" strike="noStrike">
                <a:solidFill>
                  <a:srgbClr val="000000"/>
                </a:solidFill>
                <a:latin typeface="Times New Roman"/>
              </a:rPr>
              <a:t>Relative Sp1 mRNA</a:t>
            </a:r>
            <a:br>
              <a:rPr sz="900"/>
            </a:br>
            <a:r>
              <a:rPr b="1" lang="de-DE" sz="900" spc="-1" strike="noStrike">
                <a:solidFill>
                  <a:srgbClr val="000000"/>
                </a:solidFill>
                <a:latin typeface="Times New Roman"/>
              </a:rPr>
              <a:t>expressio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 rot="16200000">
            <a:off x="724680" y="1915200"/>
            <a:ext cx="52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DMS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 rot="16200000">
            <a:off x="1200240" y="1843200"/>
            <a:ext cx="255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Enz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1040760" y="2306520"/>
            <a:ext cx="276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24 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1764360" y="2309760"/>
            <a:ext cx="276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8 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 rot="16200000">
            <a:off x="1451880" y="1914480"/>
            <a:ext cx="5238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DMS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 rot="16200000">
            <a:off x="1930680" y="1846440"/>
            <a:ext cx="255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Enz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914400" y="2314440"/>
            <a:ext cx="503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1641600" y="2314440"/>
            <a:ext cx="503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2865600" y="1068480"/>
            <a:ext cx="145800" cy="711000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3228840" y="1185840"/>
            <a:ext cx="142920" cy="593640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3589200" y="977760"/>
            <a:ext cx="146160" cy="801720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3952800" y="1368360"/>
            <a:ext cx="142920" cy="411120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 flipV="1">
            <a:off x="2936880" y="971280"/>
            <a:ext cx="1440" cy="96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2925720" y="971640"/>
            <a:ext cx="255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 flipV="1">
            <a:off x="3300480" y="1133280"/>
            <a:ext cx="1440" cy="52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3289320" y="1133640"/>
            <a:ext cx="255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 flipV="1">
            <a:off x="3660840" y="944640"/>
            <a:ext cx="1440" cy="331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3649680" y="944640"/>
            <a:ext cx="255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 flipV="1">
            <a:off x="4024440" y="1290600"/>
            <a:ext cx="1440" cy="77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4013280" y="1290600"/>
            <a:ext cx="252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2755800" y="839880"/>
            <a:ext cx="1800" cy="939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2736720" y="1779480"/>
            <a:ext cx="19080" cy="180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2736720" y="1622520"/>
            <a:ext cx="19080" cy="144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2736720" y="1467000"/>
            <a:ext cx="19080" cy="144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2736720" y="1309680"/>
            <a:ext cx="19080" cy="144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2736720" y="1154160"/>
            <a:ext cx="19080" cy="144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2736720" y="996840"/>
            <a:ext cx="19080" cy="180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2736720" y="839880"/>
            <a:ext cx="19080" cy="144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2755800" y="1779480"/>
            <a:ext cx="14479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 flipV="1">
            <a:off x="2755800" y="1779120"/>
            <a:ext cx="1800" cy="3348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 flipV="1">
            <a:off x="3119400" y="1779120"/>
            <a:ext cx="1800" cy="3348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 flipV="1">
            <a:off x="3479760" y="1779120"/>
            <a:ext cx="1800" cy="3348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 flipV="1">
            <a:off x="3843360" y="1779120"/>
            <a:ext cx="1440" cy="3348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 flipV="1">
            <a:off x="4203720" y="1779120"/>
            <a:ext cx="1440" cy="3348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3246120" y="531720"/>
            <a:ext cx="390960" cy="1677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</a:rPr>
              <a:t>H129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2578320" y="171612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0.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2578320" y="156204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0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2578320" y="140328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0.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2578320" y="124452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0.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2579760" y="109044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0.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2579760" y="93204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1.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2579760" y="77472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1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 rot="16200000">
            <a:off x="2682360" y="1915200"/>
            <a:ext cx="52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DMS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 rot="16200000">
            <a:off x="3157560" y="1843200"/>
            <a:ext cx="255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Enz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2998080" y="2306520"/>
            <a:ext cx="276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24 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3722040" y="2309760"/>
            <a:ext cx="276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8 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 rot="16200000">
            <a:off x="3409200" y="1914480"/>
            <a:ext cx="5238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DMS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 rot="16200000">
            <a:off x="3888000" y="1846440"/>
            <a:ext cx="255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Enz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2871720" y="2314440"/>
            <a:ext cx="503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3598920" y="2314440"/>
            <a:ext cx="503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1220760" y="1095480"/>
            <a:ext cx="289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1944720" y="1176480"/>
            <a:ext cx="28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3898800" y="1119240"/>
            <a:ext cx="289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87480" y="33336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912960" y="3146400"/>
            <a:ext cx="145800" cy="70020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1278000" y="3570120"/>
            <a:ext cx="144360" cy="27648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1641600" y="3238560"/>
            <a:ext cx="145800" cy="60804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2004840" y="3600360"/>
            <a:ext cx="146160" cy="24624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 flipV="1">
            <a:off x="985680" y="3084480"/>
            <a:ext cx="1800" cy="619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5120" bIns="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973080" y="3084480"/>
            <a:ext cx="28800" cy="18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 flipV="1">
            <a:off x="1349280" y="3530520"/>
            <a:ext cx="1800" cy="396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1338120" y="3530520"/>
            <a:ext cx="28800" cy="18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 flipV="1">
            <a:off x="1714680" y="3046320"/>
            <a:ext cx="1440" cy="1922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1701720" y="3046320"/>
            <a:ext cx="28800" cy="18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 flipV="1">
            <a:off x="2077920" y="3554280"/>
            <a:ext cx="1800" cy="460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2065320" y="3554280"/>
            <a:ext cx="28440" cy="18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803160" y="2954160"/>
            <a:ext cx="1800" cy="892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787320" y="3846600"/>
            <a:ext cx="158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787320" y="3700440"/>
            <a:ext cx="158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787320" y="3546360"/>
            <a:ext cx="1584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787320" y="3400560"/>
            <a:ext cx="158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787320" y="3254400"/>
            <a:ext cx="158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787320" y="3100320"/>
            <a:ext cx="1584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787320" y="2954160"/>
            <a:ext cx="1584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803160" y="3846600"/>
            <a:ext cx="14572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 flipV="1">
            <a:off x="803160" y="3846600"/>
            <a:ext cx="180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 flipV="1">
            <a:off x="1168560" y="3846600"/>
            <a:ext cx="144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 flipV="1">
            <a:off x="1531800" y="3846600"/>
            <a:ext cx="180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 flipV="1">
            <a:off x="1895400" y="3846600"/>
            <a:ext cx="180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 flipV="1">
            <a:off x="2260440" y="3846600"/>
            <a:ext cx="1800" cy="316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614880" y="3774960"/>
            <a:ext cx="145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0.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614880" y="3630600"/>
            <a:ext cx="145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0.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614880" y="3476520"/>
            <a:ext cx="145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0.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614880" y="3333600"/>
            <a:ext cx="145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0.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614880" y="3184560"/>
            <a:ext cx="145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0.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616320" y="3033720"/>
            <a:ext cx="145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1.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614880" y="2884320"/>
            <a:ext cx="145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1.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 rot="16200000">
            <a:off x="-187560" y="3223080"/>
            <a:ext cx="986760" cy="2746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900" spc="-1" strike="noStrike">
                <a:solidFill>
                  <a:srgbClr val="000000"/>
                </a:solidFill>
                <a:latin typeface="Times New Roman"/>
              </a:rPr>
              <a:t>Relative Sp3 mRNA</a:t>
            </a:r>
            <a:br>
              <a:rPr sz="900"/>
            </a:br>
            <a:r>
              <a:rPr b="1" lang="de-DE" sz="900" spc="-1" strike="noStrike">
                <a:solidFill>
                  <a:srgbClr val="000000"/>
                </a:solidFill>
                <a:latin typeface="Times New Roman"/>
              </a:rPr>
              <a:t>expressio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 rot="16200000">
            <a:off x="723240" y="3996360"/>
            <a:ext cx="52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DMS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 rot="16200000">
            <a:off x="1198800" y="3924360"/>
            <a:ext cx="255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Enz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1038960" y="4387680"/>
            <a:ext cx="276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24 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1762920" y="4390920"/>
            <a:ext cx="276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8 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 rot="16200000">
            <a:off x="1450080" y="3996360"/>
            <a:ext cx="5241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DMS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 rot="16200000">
            <a:off x="1928880" y="3927600"/>
            <a:ext cx="255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Enz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1639800" y="4395960"/>
            <a:ext cx="503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1220760" y="3352680"/>
            <a:ext cx="289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1944720" y="3382920"/>
            <a:ext cx="28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888840" y="4398840"/>
            <a:ext cx="503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2865600" y="3119400"/>
            <a:ext cx="145800" cy="730440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3228840" y="3282840"/>
            <a:ext cx="142920" cy="567000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3589200" y="3014640"/>
            <a:ext cx="146160" cy="835200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3952800" y="3556080"/>
            <a:ext cx="142920" cy="293760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 flipV="1">
            <a:off x="2936880" y="3048120"/>
            <a:ext cx="1440" cy="712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2925720" y="3048120"/>
            <a:ext cx="255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 flipV="1">
            <a:off x="3300480" y="3119400"/>
            <a:ext cx="1440" cy="163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3289320" y="3119400"/>
            <a:ext cx="255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 flipV="1">
            <a:off x="3660840" y="2968560"/>
            <a:ext cx="1440" cy="46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3649680" y="2968560"/>
            <a:ext cx="255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 flipV="1">
            <a:off x="4024440" y="3530160"/>
            <a:ext cx="1440" cy="255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4013280" y="3530520"/>
            <a:ext cx="252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2755800" y="2909880"/>
            <a:ext cx="1800" cy="9399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2736720" y="3849840"/>
            <a:ext cx="19080" cy="144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2736720" y="3692520"/>
            <a:ext cx="19080" cy="144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2736720" y="3537000"/>
            <a:ext cx="19080" cy="144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2736720" y="3379680"/>
            <a:ext cx="19080" cy="180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2736720" y="3224160"/>
            <a:ext cx="19080" cy="180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2736720" y="3067200"/>
            <a:ext cx="19080" cy="144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2736720" y="2909880"/>
            <a:ext cx="19080" cy="144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2755800" y="3849840"/>
            <a:ext cx="14479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 flipV="1">
            <a:off x="2755800" y="3849840"/>
            <a:ext cx="1800" cy="3312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 flipV="1">
            <a:off x="3119400" y="3849840"/>
            <a:ext cx="1800" cy="3312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 flipV="1">
            <a:off x="3479760" y="3849840"/>
            <a:ext cx="1800" cy="3312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 flipV="1">
            <a:off x="3843360" y="3849840"/>
            <a:ext cx="1440" cy="3312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 flipV="1">
            <a:off x="4203720" y="3849840"/>
            <a:ext cx="1440" cy="33120"/>
          </a:xfrm>
          <a:prstGeom prst="line">
            <a:avLst/>
          </a:prstGeom>
          <a:ln w="0">
            <a:solidFill>
              <a:srgbClr val="80808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2568600" y="378144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0.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2570400" y="363384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0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2568600" y="347832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0.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2570400" y="332100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0.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2568600" y="316548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0.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2568600" y="300348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1.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2568600" y="285120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1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 rot="16200000">
            <a:off x="2672640" y="3996360"/>
            <a:ext cx="52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DMS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 rot="16200000">
            <a:off x="3148200" y="3924360"/>
            <a:ext cx="255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Enz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2988360" y="4387680"/>
            <a:ext cx="276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24 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3712320" y="4390920"/>
            <a:ext cx="2764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48 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 rot="16200000">
            <a:off x="3399480" y="3996360"/>
            <a:ext cx="5241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DMS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 rot="16200000">
            <a:off x="3878280" y="3927600"/>
            <a:ext cx="2552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Enz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3589200" y="4395960"/>
            <a:ext cx="503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2838600" y="4398840"/>
            <a:ext cx="502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3894120" y="3344760"/>
            <a:ext cx="289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1304280" y="2597040"/>
            <a:ext cx="339120" cy="182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5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3247560" y="2603520"/>
            <a:ext cx="390960" cy="1677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</a:rPr>
              <a:t>H129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87480" y="242244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20" name=""/>
          <p:cNvGrpSpPr/>
          <p:nvPr/>
        </p:nvGrpSpPr>
        <p:grpSpPr>
          <a:xfrm>
            <a:off x="2563920" y="4959360"/>
            <a:ext cx="1673280" cy="1684800"/>
            <a:chOff x="2563920" y="4959360"/>
            <a:chExt cx="1673280" cy="1684800"/>
          </a:xfrm>
        </p:grpSpPr>
        <p:sp>
          <p:nvSpPr>
            <p:cNvPr id="221" name=""/>
            <p:cNvSpPr/>
            <p:nvPr/>
          </p:nvSpPr>
          <p:spPr>
            <a:xfrm>
              <a:off x="2867040" y="5348520"/>
              <a:ext cx="150840" cy="57276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3240000" y="5453280"/>
              <a:ext cx="144720" cy="46800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3605400" y="5275440"/>
              <a:ext cx="152280" cy="64584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3979800" y="5502240"/>
              <a:ext cx="144720" cy="41904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 flipV="1">
              <a:off x="2941560" y="5324040"/>
              <a:ext cx="1800" cy="241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2921040" y="5324400"/>
              <a:ext cx="4932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 flipV="1">
              <a:off x="3308400" y="5428800"/>
              <a:ext cx="1440" cy="241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3287880" y="5429160"/>
              <a:ext cx="4896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 flipV="1">
              <a:off x="3681360" y="5162400"/>
              <a:ext cx="1800" cy="112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3660840" y="5162760"/>
              <a:ext cx="493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 flipV="1">
              <a:off x="4048200" y="5469120"/>
              <a:ext cx="1440" cy="331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4027680" y="5469120"/>
              <a:ext cx="489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2755800" y="5025960"/>
              <a:ext cx="1800" cy="895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2735280" y="5921280"/>
              <a:ext cx="205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2735280" y="5808600"/>
              <a:ext cx="205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2735280" y="5695920"/>
              <a:ext cx="205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2735280" y="5581800"/>
              <a:ext cx="20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2735280" y="5477040"/>
              <a:ext cx="20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2735280" y="5364360"/>
              <a:ext cx="20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2735280" y="5251680"/>
              <a:ext cx="20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>
              <a:off x="2735280" y="5138640"/>
              <a:ext cx="205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>
              <a:off x="2735280" y="5025960"/>
              <a:ext cx="205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>
              <a:off x="2755800" y="5921280"/>
              <a:ext cx="14796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 flipV="1">
              <a:off x="2755800" y="5920920"/>
              <a:ext cx="1800" cy="24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 flipV="1">
              <a:off x="3129120" y="5920920"/>
              <a:ext cx="1440" cy="24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 flipV="1">
              <a:off x="3495600" y="5920920"/>
              <a:ext cx="1800" cy="24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 flipV="1">
              <a:off x="3868920" y="5920920"/>
              <a:ext cx="1440" cy="24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 flipV="1">
              <a:off x="4235400" y="5920920"/>
              <a:ext cx="1800" cy="24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2565360" y="585144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0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2563920" y="574200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0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2563920" y="562932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0.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2563920" y="551664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0.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2563920" y="541188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0.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2563920" y="529452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1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2563920" y="518652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1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2563920" y="507204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1.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2563920" y="495936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1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 rot="16200000">
              <a:off x="2672640" y="6066720"/>
              <a:ext cx="527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DMSO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 rot="16200000">
              <a:off x="3162600" y="5994720"/>
              <a:ext cx="255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Enz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2988360" y="6458040"/>
              <a:ext cx="2764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24 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3712320" y="6461280"/>
              <a:ext cx="2764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48 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 rot="16200000">
              <a:off x="3409200" y="6066000"/>
              <a:ext cx="5238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DMSO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 rot="16200000">
              <a:off x="3916440" y="5997960"/>
              <a:ext cx="255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Enz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3603600" y="6465960"/>
              <a:ext cx="503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2862360" y="6469200"/>
              <a:ext cx="503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66" name=""/>
          <p:cNvSpPr/>
          <p:nvPr/>
        </p:nvSpPr>
        <p:spPr>
          <a:xfrm rot="16200000">
            <a:off x="-234720" y="5347080"/>
            <a:ext cx="1075320" cy="2746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900" spc="-1" strike="noStrike">
                <a:solidFill>
                  <a:srgbClr val="000000"/>
                </a:solidFill>
                <a:latin typeface="Times New Roman"/>
              </a:rPr>
              <a:t>Relative c-Jun mRNA</a:t>
            </a:r>
            <a:br>
              <a:rPr sz="900"/>
            </a:br>
            <a:r>
              <a:rPr b="1" lang="de-DE" sz="900" spc="-1" strike="noStrike">
                <a:solidFill>
                  <a:srgbClr val="000000"/>
                </a:solidFill>
                <a:latin typeface="Times New Roman"/>
              </a:rPr>
              <a:t> expression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67" name=""/>
          <p:cNvGrpSpPr/>
          <p:nvPr/>
        </p:nvGrpSpPr>
        <p:grpSpPr>
          <a:xfrm>
            <a:off x="633600" y="4946760"/>
            <a:ext cx="1620720" cy="1702080"/>
            <a:chOff x="633600" y="4946760"/>
            <a:chExt cx="1620720" cy="1702080"/>
          </a:xfrm>
        </p:grpSpPr>
        <p:sp>
          <p:nvSpPr>
            <p:cNvPr id="268" name=""/>
            <p:cNvSpPr/>
            <p:nvPr/>
          </p:nvSpPr>
          <p:spPr>
            <a:xfrm>
              <a:off x="912960" y="5241960"/>
              <a:ext cx="142920" cy="67788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1273320" y="5497560"/>
              <a:ext cx="147600" cy="42228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1640160" y="5218200"/>
              <a:ext cx="142920" cy="70164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>
              <a:off x="2001960" y="5856120"/>
              <a:ext cx="141480" cy="6372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 flipV="1">
              <a:off x="984600" y="5193720"/>
              <a:ext cx="1440" cy="4788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" bIns="1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>
              <a:off x="966960" y="5194080"/>
              <a:ext cx="39600" cy="18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 flipV="1">
              <a:off x="1344960" y="5449320"/>
              <a:ext cx="1440" cy="4788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" bIns="1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>
              <a:off x="1329120" y="5449680"/>
              <a:ext cx="37800" cy="18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 flipV="1">
              <a:off x="1711440" y="5162040"/>
              <a:ext cx="1800" cy="558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1695600" y="5162400"/>
              <a:ext cx="38160" cy="18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 flipV="1">
              <a:off x="2071800" y="5848200"/>
              <a:ext cx="1800" cy="792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>
              <a:off x="2055960" y="5848200"/>
              <a:ext cx="38160" cy="18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803520" y="5002200"/>
              <a:ext cx="1440" cy="917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>
              <a:off x="787680" y="591984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>
              <a:off x="787680" y="579276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"/>
            <p:cNvSpPr/>
            <p:nvPr/>
          </p:nvSpPr>
          <p:spPr>
            <a:xfrm>
              <a:off x="787680" y="565632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>
              <a:off x="787680" y="552924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>
              <a:off x="787680" y="539424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"/>
            <p:cNvSpPr/>
            <p:nvPr/>
          </p:nvSpPr>
          <p:spPr>
            <a:xfrm>
              <a:off x="787680" y="526572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"/>
            <p:cNvSpPr/>
            <p:nvPr/>
          </p:nvSpPr>
          <p:spPr>
            <a:xfrm>
              <a:off x="787680" y="513072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>
              <a:off x="787680" y="500220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803520" y="5919840"/>
              <a:ext cx="14493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"/>
            <p:cNvSpPr/>
            <p:nvPr/>
          </p:nvSpPr>
          <p:spPr>
            <a:xfrm flipV="1">
              <a:off x="803520" y="5919840"/>
              <a:ext cx="144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 flipV="1">
              <a:off x="1163880" y="5919840"/>
              <a:ext cx="144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 flipV="1">
              <a:off x="1530720" y="5919840"/>
              <a:ext cx="144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 flipV="1">
              <a:off x="1892520" y="5919840"/>
              <a:ext cx="144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"/>
            <p:cNvSpPr/>
            <p:nvPr/>
          </p:nvSpPr>
          <p:spPr>
            <a:xfrm flipV="1">
              <a:off x="2252880" y="5919840"/>
              <a:ext cx="1440" cy="23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"/>
            <p:cNvSpPr/>
            <p:nvPr/>
          </p:nvSpPr>
          <p:spPr>
            <a:xfrm>
              <a:off x="633600" y="586584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0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"/>
            <p:cNvSpPr/>
            <p:nvPr/>
          </p:nvSpPr>
          <p:spPr>
            <a:xfrm>
              <a:off x="633600" y="573552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0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"/>
            <p:cNvSpPr/>
            <p:nvPr/>
          </p:nvSpPr>
          <p:spPr>
            <a:xfrm>
              <a:off x="633600" y="560052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0.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"/>
            <p:cNvSpPr/>
            <p:nvPr/>
          </p:nvSpPr>
          <p:spPr>
            <a:xfrm>
              <a:off x="633600" y="547380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0.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>
              <a:off x="633600" y="533700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0.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"/>
            <p:cNvSpPr/>
            <p:nvPr/>
          </p:nvSpPr>
          <p:spPr>
            <a:xfrm>
              <a:off x="633600" y="520848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1.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"/>
            <p:cNvSpPr/>
            <p:nvPr/>
          </p:nvSpPr>
          <p:spPr>
            <a:xfrm>
              <a:off x="633600" y="507528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1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"/>
            <p:cNvSpPr/>
            <p:nvPr/>
          </p:nvSpPr>
          <p:spPr>
            <a:xfrm>
              <a:off x="633600" y="4946760"/>
              <a:ext cx="13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1.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"/>
            <p:cNvSpPr/>
            <p:nvPr/>
          </p:nvSpPr>
          <p:spPr>
            <a:xfrm rot="16200000">
              <a:off x="718560" y="6071040"/>
              <a:ext cx="527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DMSO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"/>
            <p:cNvSpPr/>
            <p:nvPr/>
          </p:nvSpPr>
          <p:spPr>
            <a:xfrm rot="16200000">
              <a:off x="1198800" y="5999400"/>
              <a:ext cx="255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Enz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"/>
            <p:cNvSpPr/>
            <p:nvPr/>
          </p:nvSpPr>
          <p:spPr>
            <a:xfrm>
              <a:off x="1034640" y="6462720"/>
              <a:ext cx="2764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24 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1758240" y="6465960"/>
              <a:ext cx="2764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48 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"/>
            <p:cNvSpPr/>
            <p:nvPr/>
          </p:nvSpPr>
          <p:spPr>
            <a:xfrm rot="16200000">
              <a:off x="1445760" y="6070680"/>
              <a:ext cx="5238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DMSO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"/>
            <p:cNvSpPr/>
            <p:nvPr/>
          </p:nvSpPr>
          <p:spPr>
            <a:xfrm rot="16200000">
              <a:off x="1929240" y="6002640"/>
              <a:ext cx="255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Enz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"/>
            <p:cNvSpPr/>
            <p:nvPr/>
          </p:nvSpPr>
          <p:spPr>
            <a:xfrm>
              <a:off x="1635480" y="6470640"/>
              <a:ext cx="502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"/>
            <p:cNvSpPr/>
            <p:nvPr/>
          </p:nvSpPr>
          <p:spPr>
            <a:xfrm>
              <a:off x="884520" y="6473880"/>
              <a:ext cx="503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11" name=""/>
          <p:cNvSpPr/>
          <p:nvPr/>
        </p:nvSpPr>
        <p:spPr>
          <a:xfrm>
            <a:off x="1302840" y="4676760"/>
            <a:ext cx="339120" cy="182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5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"/>
          <p:cNvSpPr/>
          <p:nvPr/>
        </p:nvSpPr>
        <p:spPr>
          <a:xfrm>
            <a:off x="3246120" y="4683240"/>
            <a:ext cx="390960" cy="1677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</a:rPr>
              <a:t>H129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>
            <a:off x="85680" y="450216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c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"/>
          <p:cNvSpPr/>
          <p:nvPr/>
        </p:nvSpPr>
        <p:spPr>
          <a:xfrm>
            <a:off x="1212840" y="525312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"/>
          <p:cNvSpPr/>
          <p:nvPr/>
        </p:nvSpPr>
        <p:spPr>
          <a:xfrm>
            <a:off x="1933560" y="565308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>
            <a:off x="3906720" y="528804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317" name=""/>
          <p:cNvGraphicFramePr/>
          <p:nvPr/>
        </p:nvGraphicFramePr>
        <p:xfrm>
          <a:off x="5021280" y="1316160"/>
          <a:ext cx="900000" cy="3603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318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5021280" y="1316160"/>
                    <a:ext cx="900000" cy="36036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319" name=""/>
          <p:cNvGraphicFramePr/>
          <p:nvPr/>
        </p:nvGraphicFramePr>
        <p:xfrm>
          <a:off x="5964120" y="1309680"/>
          <a:ext cx="900360" cy="36036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320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5964120" y="1309680"/>
                    <a:ext cx="900360" cy="36036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321" name=""/>
          <p:cNvGraphicFramePr/>
          <p:nvPr/>
        </p:nvGraphicFramePr>
        <p:xfrm>
          <a:off x="5964120" y="912960"/>
          <a:ext cx="900360" cy="36036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322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5964120" y="912960"/>
                    <a:ext cx="900360" cy="36036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323" name=""/>
          <p:cNvGraphicFramePr/>
          <p:nvPr/>
        </p:nvGraphicFramePr>
        <p:xfrm>
          <a:off x="5021280" y="917640"/>
          <a:ext cx="900000" cy="36036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324" name="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5021280" y="917640"/>
                    <a:ext cx="900000" cy="36036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325" name=""/>
          <p:cNvGraphicFramePr/>
          <p:nvPr/>
        </p:nvGraphicFramePr>
        <p:xfrm>
          <a:off x="5964120" y="1714680"/>
          <a:ext cx="900360" cy="36036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326" name="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5964120" y="1714680"/>
                    <a:ext cx="900360" cy="36036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327" name=""/>
          <p:cNvGraphicFramePr/>
          <p:nvPr/>
        </p:nvGraphicFramePr>
        <p:xfrm>
          <a:off x="5021280" y="1714680"/>
          <a:ext cx="900000" cy="36036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328" name="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5021280" y="1714680"/>
                    <a:ext cx="900000" cy="36036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329" name=""/>
          <p:cNvGraphicFramePr/>
          <p:nvPr/>
        </p:nvGraphicFramePr>
        <p:xfrm>
          <a:off x="5964120" y="2108160"/>
          <a:ext cx="900360" cy="360360"/>
        </p:xfrm>
        <a:graphic>
          <a:graphicData uri="http://schemas.openxmlformats.org/presentationml/2006/ole">
            <p:oleObj r:id="rId13" spid="">
              <p:embed/>
              <p:pic>
                <p:nvPicPr>
                  <p:cNvPr id="330" name="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5964120" y="2108160"/>
                    <a:ext cx="900360" cy="36036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graphicFrame>
        <p:nvGraphicFramePr>
          <p:cNvPr id="331" name=""/>
          <p:cNvGraphicFramePr/>
          <p:nvPr/>
        </p:nvGraphicFramePr>
        <p:xfrm>
          <a:off x="5022720" y="2112840"/>
          <a:ext cx="900360" cy="360360"/>
        </p:xfrm>
        <a:graphic>
          <a:graphicData uri="http://schemas.openxmlformats.org/presentationml/2006/ole">
            <p:oleObj r:id="rId15" spid="">
              <p:embed/>
              <p:pic>
                <p:nvPicPr>
                  <p:cNvPr id="332" name="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5022720" y="2112840"/>
                    <a:ext cx="900360" cy="36036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oleObj>
          </a:graphicData>
        </a:graphic>
      </p:graphicFrame>
      <p:sp>
        <p:nvSpPr>
          <p:cNvPr id="333" name=""/>
          <p:cNvSpPr/>
          <p:nvPr/>
        </p:nvSpPr>
        <p:spPr>
          <a:xfrm>
            <a:off x="5003640" y="673200"/>
            <a:ext cx="936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   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        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"/>
          <p:cNvSpPr/>
          <p:nvPr/>
        </p:nvSpPr>
        <p:spPr>
          <a:xfrm>
            <a:off x="5877000" y="668160"/>
            <a:ext cx="936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   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        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"/>
          <p:cNvSpPr/>
          <p:nvPr/>
        </p:nvSpPr>
        <p:spPr>
          <a:xfrm>
            <a:off x="5076720" y="692280"/>
            <a:ext cx="719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"/>
          <p:cNvSpPr/>
          <p:nvPr/>
        </p:nvSpPr>
        <p:spPr>
          <a:xfrm>
            <a:off x="6022800" y="692280"/>
            <a:ext cx="719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"/>
          <p:cNvSpPr/>
          <p:nvPr/>
        </p:nvSpPr>
        <p:spPr>
          <a:xfrm>
            <a:off x="4894200" y="2449440"/>
            <a:ext cx="1368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1: DMSO; 2 Enz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"/>
          <p:cNvSpPr/>
          <p:nvPr/>
        </p:nvSpPr>
        <p:spPr>
          <a:xfrm>
            <a:off x="6832440" y="1301760"/>
            <a:ext cx="64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p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"/>
          <p:cNvSpPr/>
          <p:nvPr/>
        </p:nvSpPr>
        <p:spPr>
          <a:xfrm>
            <a:off x="6832440" y="912960"/>
            <a:ext cx="64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p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"/>
          <p:cNvSpPr/>
          <p:nvPr/>
        </p:nvSpPr>
        <p:spPr>
          <a:xfrm>
            <a:off x="6832440" y="1724040"/>
            <a:ext cx="64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c-Ju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Textfeld 17"/>
          <p:cNvSpPr/>
          <p:nvPr/>
        </p:nvSpPr>
        <p:spPr>
          <a:xfrm>
            <a:off x="6843600" y="2133720"/>
            <a:ext cx="752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β</a:t>
            </a:r>
            <a:r>
              <a:rPr b="1" lang="de-DE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"/>
          <p:cNvSpPr/>
          <p:nvPr/>
        </p:nvSpPr>
        <p:spPr>
          <a:xfrm>
            <a:off x="4716360" y="333360"/>
            <a:ext cx="36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d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"/>
          <p:cNvSpPr/>
          <p:nvPr/>
        </p:nvSpPr>
        <p:spPr>
          <a:xfrm>
            <a:off x="5297040" y="466560"/>
            <a:ext cx="339120" cy="182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5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"/>
          <p:cNvSpPr/>
          <p:nvPr/>
        </p:nvSpPr>
        <p:spPr>
          <a:xfrm>
            <a:off x="6159240" y="485640"/>
            <a:ext cx="390960" cy="1677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</a:rPr>
              <a:t>H129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5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13T11:42:16Z</dcterms:created>
  <dc:creator>Mudduluru</dc:creator>
  <dc:description/>
  <dc:language>en-US</dc:language>
  <cp:lastModifiedBy>mudduluru</cp:lastModifiedBy>
  <dcterms:modified xsi:type="dcterms:W3CDTF">2010-05-03T06:17:45Z</dcterms:modified>
  <cp:revision>100</cp:revision>
  <dc:subject/>
  <dc:title>Folie 1</dc:title>
</cp:coreProperties>
</file>